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59" r:id="rId2"/>
    <p:sldId id="256" r:id="rId3"/>
    <p:sldId id="257" r:id="rId4"/>
    <p:sldId id="258" r:id="rId5"/>
    <p:sldId id="260" r:id="rId6"/>
    <p:sldId id="261" r:id="rId7"/>
    <p:sldId id="262" r:id="rId8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1" d="100"/>
          <a:sy n="41" d="100"/>
        </p:scale>
        <p:origin x="2316" y="36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52D322D-B390-413B-A13D-F21C221BB1F1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6923A9C-88B7-4014-ABEA-A4F8B4436B4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98413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923A9C-88B7-4014-ABEA-A4F8B4436B47}" type="slidenum">
              <a:rPr lang="en-IN" smtClean="0"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8998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1441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9587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0419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6000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3724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627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0010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2933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5648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625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8171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8FD92-BD9F-4BD8-9EBF-831985A58233}" type="datetimeFigureOut">
              <a:rPr lang="en-IN" smtClean="0"/>
              <a:t>06-03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A6438-A99B-43DF-93E2-201EDFEDEED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2096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tmp"/><Relationship Id="rId4" Type="http://schemas.openxmlformats.org/officeDocument/2006/relationships/image" Target="../media/image4.tm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mp"/><Relationship Id="rId7" Type="http://schemas.openxmlformats.org/officeDocument/2006/relationships/image" Target="../media/image13.png"/><Relationship Id="rId2" Type="http://schemas.openxmlformats.org/officeDocument/2006/relationships/image" Target="../media/image9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1.wdp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mp"/><Relationship Id="rId3" Type="http://schemas.openxmlformats.org/officeDocument/2006/relationships/image" Target="../media/image14.tmp"/><Relationship Id="rId7" Type="http://schemas.openxmlformats.org/officeDocument/2006/relationships/image" Target="../media/image18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mp"/><Relationship Id="rId5" Type="http://schemas.openxmlformats.org/officeDocument/2006/relationships/image" Target="../media/image16.tmp"/><Relationship Id="rId4" Type="http://schemas.openxmlformats.org/officeDocument/2006/relationships/image" Target="../media/image15.tm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mp"/><Relationship Id="rId3" Type="http://schemas.openxmlformats.org/officeDocument/2006/relationships/image" Target="../media/image21.tmp"/><Relationship Id="rId7" Type="http://schemas.openxmlformats.org/officeDocument/2006/relationships/image" Target="../media/image25.tmp"/><Relationship Id="rId2" Type="http://schemas.openxmlformats.org/officeDocument/2006/relationships/image" Target="../media/image20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mp"/><Relationship Id="rId5" Type="http://schemas.openxmlformats.org/officeDocument/2006/relationships/image" Target="../media/image23.tmp"/><Relationship Id="rId4" Type="http://schemas.openxmlformats.org/officeDocument/2006/relationships/image" Target="../media/image22.tmp"/><Relationship Id="rId9" Type="http://schemas.openxmlformats.org/officeDocument/2006/relationships/image" Target="../media/image27.tm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5034E146-713A-2BB3-5D27-BF5B577F6B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959" y="1461898"/>
            <a:ext cx="6312699" cy="430027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AFC65A8-A8CE-FED6-144E-23FAA3CD55C3}"/>
              </a:ext>
            </a:extLst>
          </p:cNvPr>
          <p:cNvSpPr txBox="1"/>
          <p:nvPr/>
        </p:nvSpPr>
        <p:spPr>
          <a:xfrm>
            <a:off x="85726" y="8572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Suppl. Figure 1</a:t>
            </a:r>
          </a:p>
        </p:txBody>
      </p:sp>
    </p:spTree>
    <p:extLst>
      <p:ext uri="{BB962C8B-B14F-4D97-AF65-F5344CB8AC3E}">
        <p14:creationId xmlns:p14="http://schemas.microsoft.com/office/powerpoint/2010/main" val="965731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7E338A9-A0E9-A25F-A8C2-EB92482239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18" t="17725" r="36482" b="17460"/>
          <a:stretch/>
        </p:blipFill>
        <p:spPr>
          <a:xfrm>
            <a:off x="250694" y="734141"/>
            <a:ext cx="3755831" cy="309824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4298730-B71D-DB6A-779A-CEAEEED825F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70024"/>
          <a:stretch>
            <a:fillRect/>
          </a:stretch>
        </p:blipFill>
        <p:spPr>
          <a:xfrm>
            <a:off x="1675011" y="7539005"/>
            <a:ext cx="1049716" cy="177493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1B0DBE4-309F-12D2-6D1B-E7484ABA32F7}"/>
              </a:ext>
            </a:extLst>
          </p:cNvPr>
          <p:cNvSpPr txBox="1"/>
          <p:nvPr/>
        </p:nvSpPr>
        <p:spPr>
          <a:xfrm>
            <a:off x="85726" y="8572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Suppl. Figure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F438AB2-416B-E69E-6EF8-A976DEFB8169}"/>
              </a:ext>
            </a:extLst>
          </p:cNvPr>
          <p:cNvSpPr txBox="1"/>
          <p:nvPr/>
        </p:nvSpPr>
        <p:spPr>
          <a:xfrm>
            <a:off x="85726" y="58370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A)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820C1E-BA3D-4A94-CA33-75EF9A214C44}"/>
              </a:ext>
            </a:extLst>
          </p:cNvPr>
          <p:cNvSpPr txBox="1"/>
          <p:nvPr/>
        </p:nvSpPr>
        <p:spPr>
          <a:xfrm>
            <a:off x="3783547" y="528274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B)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9490731-DB1B-2F0B-BD9C-D220CF5F8678}"/>
              </a:ext>
            </a:extLst>
          </p:cNvPr>
          <p:cNvSpPr txBox="1"/>
          <p:nvPr/>
        </p:nvSpPr>
        <p:spPr>
          <a:xfrm>
            <a:off x="85726" y="4019135"/>
            <a:ext cx="439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C)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0C0EFA2-5CDC-F443-B8C1-9E16B815DC3C}"/>
              </a:ext>
            </a:extLst>
          </p:cNvPr>
          <p:cNvSpPr txBox="1"/>
          <p:nvPr/>
        </p:nvSpPr>
        <p:spPr>
          <a:xfrm>
            <a:off x="923023" y="7385116"/>
            <a:ext cx="3898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i).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655D095-08D9-D171-A588-D4F24DA9657D}"/>
              </a:ext>
            </a:extLst>
          </p:cNvPr>
          <p:cNvSpPr txBox="1"/>
          <p:nvPr/>
        </p:nvSpPr>
        <p:spPr>
          <a:xfrm>
            <a:off x="2496788" y="7385115"/>
            <a:ext cx="434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ii).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9D54A1E-7396-C6B7-406F-F9E739F954DD}"/>
              </a:ext>
            </a:extLst>
          </p:cNvPr>
          <p:cNvSpPr txBox="1"/>
          <p:nvPr/>
        </p:nvSpPr>
        <p:spPr>
          <a:xfrm>
            <a:off x="3749885" y="7385115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iii)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F4077A-0D41-C79F-9B0C-CA06670281D8}"/>
              </a:ext>
            </a:extLst>
          </p:cNvPr>
          <p:cNvSpPr txBox="1"/>
          <p:nvPr/>
        </p:nvSpPr>
        <p:spPr>
          <a:xfrm>
            <a:off x="100152" y="6652263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D).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D692AFF-BBBE-0B0E-56A0-3B2B41D474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8742" y="4488234"/>
            <a:ext cx="1824161" cy="178815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640567D-BA99-6724-E08D-9392319A71A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6443" y="4488233"/>
            <a:ext cx="1877566" cy="178815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BB4E296-DC17-F2F3-0F8F-71A37ED1618C}"/>
              </a:ext>
            </a:extLst>
          </p:cNvPr>
          <p:cNvSpPr txBox="1"/>
          <p:nvPr/>
        </p:nvSpPr>
        <p:spPr>
          <a:xfrm>
            <a:off x="1762452" y="4349734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 + IgG isotype 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84D1CA8-7CB3-872D-D75A-634DD148F9FE}"/>
              </a:ext>
            </a:extLst>
          </p:cNvPr>
          <p:cNvSpPr txBox="1"/>
          <p:nvPr/>
        </p:nvSpPr>
        <p:spPr>
          <a:xfrm>
            <a:off x="3534834" y="4349734"/>
            <a:ext cx="15358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 + LFA-1 αI-Fc 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AFE45FF5-4091-53E1-5B39-54AB7BA7C81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b="22944"/>
          <a:stretch>
            <a:fillRect/>
          </a:stretch>
        </p:blipFill>
        <p:spPr>
          <a:xfrm>
            <a:off x="3937899" y="1135040"/>
            <a:ext cx="1395456" cy="2090579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79EEE16E-1E64-54EE-960F-CAD73C1A164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64728" y="1092015"/>
            <a:ext cx="1708728" cy="2133604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6088CCC9-CCA6-9442-AA89-4BC89C2D01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04119" y="7668896"/>
            <a:ext cx="1233780" cy="1645040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D01FE14B-9F38-DE37-570D-44689606708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9070"/>
          <a:stretch>
            <a:fillRect/>
          </a:stretch>
        </p:blipFill>
        <p:spPr>
          <a:xfrm>
            <a:off x="4302736" y="7539005"/>
            <a:ext cx="1083139" cy="1774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6397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D75BC830-4854-6083-0DC7-71863309D111}"/>
              </a:ext>
            </a:extLst>
          </p:cNvPr>
          <p:cNvGrpSpPr/>
          <p:nvPr/>
        </p:nvGrpSpPr>
        <p:grpSpPr>
          <a:xfrm>
            <a:off x="617301" y="6255995"/>
            <a:ext cx="5623398" cy="3132706"/>
            <a:chOff x="242729" y="6255995"/>
            <a:chExt cx="5623398" cy="3132706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59C8014-187F-0D8F-974F-5808770254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4993" y="6394496"/>
              <a:ext cx="2715004" cy="248637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EAEF738-E1F1-72AF-4795-4D01F1CD2B0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13071" y="6466317"/>
              <a:ext cx="2553056" cy="2553056"/>
            </a:xfrm>
            <a:prstGeom prst="rect">
              <a:avLst/>
            </a:prstGeom>
          </p:spPr>
        </p:pic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659E85CC-34BD-7556-2794-FCE33C2491A5}"/>
                </a:ext>
              </a:extLst>
            </p:cNvPr>
            <p:cNvCxnSpPr/>
            <p:nvPr/>
          </p:nvCxnSpPr>
          <p:spPr>
            <a:xfrm flipV="1">
              <a:off x="604993" y="7148828"/>
              <a:ext cx="0" cy="82999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D5454066-E193-8276-BB82-FCFFD77C0F08}"/>
                </a:ext>
              </a:extLst>
            </p:cNvPr>
            <p:cNvCxnSpPr/>
            <p:nvPr/>
          </p:nvCxnSpPr>
          <p:spPr>
            <a:xfrm>
              <a:off x="1465437" y="9054885"/>
              <a:ext cx="90033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A08238B4-9F62-3F3F-3EE9-0B857DE53586}"/>
                </a:ext>
              </a:extLst>
            </p:cNvPr>
            <p:cNvCxnSpPr/>
            <p:nvPr/>
          </p:nvCxnSpPr>
          <p:spPr>
            <a:xfrm flipV="1">
              <a:off x="3410463" y="7148829"/>
              <a:ext cx="0" cy="82999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764D8E77-B3E9-78D4-4C78-EDF5C9489E4E}"/>
                </a:ext>
              </a:extLst>
            </p:cNvPr>
            <p:cNvCxnSpPr>
              <a:cxnSpLocks/>
            </p:cNvCxnSpPr>
            <p:nvPr/>
          </p:nvCxnSpPr>
          <p:spPr>
            <a:xfrm>
              <a:off x="4333198" y="9054885"/>
              <a:ext cx="101287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B67D109-6B0F-3D14-B4F7-4E95AB5FD23F}"/>
                </a:ext>
              </a:extLst>
            </p:cNvPr>
            <p:cNvSpPr txBox="1"/>
            <p:nvPr/>
          </p:nvSpPr>
          <p:spPr>
            <a:xfrm>
              <a:off x="4497233" y="9019369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56</a:t>
              </a:r>
              <a:endParaRPr lang="en-IN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35C0AA5-B21D-9953-4B84-8CFF7A1F4526}"/>
                </a:ext>
              </a:extLst>
            </p:cNvPr>
            <p:cNvSpPr txBox="1"/>
            <p:nvPr/>
          </p:nvSpPr>
          <p:spPr>
            <a:xfrm>
              <a:off x="1546314" y="9019369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56</a:t>
              </a:r>
              <a:endParaRPr lang="en-IN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14061D1-D800-93B4-1E6A-5D0FE1770919}"/>
                </a:ext>
              </a:extLst>
            </p:cNvPr>
            <p:cNvSpPr txBox="1"/>
            <p:nvPr/>
          </p:nvSpPr>
          <p:spPr>
            <a:xfrm rot="16200000">
              <a:off x="143503" y="7379159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3</a:t>
              </a:r>
              <a:endParaRPr lang="en-IN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0967203-C7A4-B063-39D9-7A262825170D}"/>
                </a:ext>
              </a:extLst>
            </p:cNvPr>
            <p:cNvSpPr txBox="1"/>
            <p:nvPr/>
          </p:nvSpPr>
          <p:spPr>
            <a:xfrm rot="16200000">
              <a:off x="2956039" y="7387186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D3</a:t>
              </a:r>
              <a:endParaRPr lang="en-IN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1E1DD59-2A46-FB77-8709-4EDF6E115892}"/>
                </a:ext>
              </a:extLst>
            </p:cNvPr>
            <p:cNvSpPr txBox="1"/>
            <p:nvPr/>
          </p:nvSpPr>
          <p:spPr>
            <a:xfrm>
              <a:off x="1546314" y="6255995"/>
              <a:ext cx="8194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unstained</a:t>
              </a:r>
              <a:endParaRPr lang="en-IN" sz="1200" b="1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D647008-EC5A-32E3-9CA0-C78ABB686E84}"/>
                </a:ext>
              </a:extLst>
            </p:cNvPr>
            <p:cNvSpPr txBox="1"/>
            <p:nvPr/>
          </p:nvSpPr>
          <p:spPr>
            <a:xfrm>
              <a:off x="4482828" y="6255996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stained</a:t>
              </a:r>
              <a:endParaRPr lang="en-IN" sz="1200" b="1" dirty="0"/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A27F1654-8C64-6379-703A-B0A29FA528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5626" t="4907" r="10002" b="22266"/>
          <a:stretch/>
        </p:blipFill>
        <p:spPr>
          <a:xfrm flipH="1">
            <a:off x="2440028" y="985285"/>
            <a:ext cx="611818" cy="125678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6FDBED6-D75D-94BC-59C0-8CD6FA9BCC9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62799" y="985285"/>
            <a:ext cx="648171" cy="128144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1D16A42-4607-5D55-0F29-B1D46BE653CA}"/>
              </a:ext>
            </a:extLst>
          </p:cNvPr>
          <p:cNvSpPr txBox="1"/>
          <p:nvPr/>
        </p:nvSpPr>
        <p:spPr>
          <a:xfrm>
            <a:off x="85726" y="8572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Suppl. Figure 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908A810-3549-3D8B-A068-D918CBA396A5}"/>
              </a:ext>
            </a:extLst>
          </p:cNvPr>
          <p:cNvSpPr txBox="1"/>
          <p:nvPr/>
        </p:nvSpPr>
        <p:spPr>
          <a:xfrm>
            <a:off x="1376294" y="393502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A)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078CD4-CF10-B2C1-A725-352C7EC6C69A}"/>
              </a:ext>
            </a:extLst>
          </p:cNvPr>
          <p:cNvSpPr txBox="1"/>
          <p:nvPr/>
        </p:nvSpPr>
        <p:spPr>
          <a:xfrm>
            <a:off x="3442084" y="393313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B)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1A76044-E5FF-C45A-7A2E-F66878A2AC25}"/>
              </a:ext>
            </a:extLst>
          </p:cNvPr>
          <p:cNvSpPr txBox="1"/>
          <p:nvPr/>
        </p:nvSpPr>
        <p:spPr>
          <a:xfrm>
            <a:off x="93740" y="2557060"/>
            <a:ext cx="439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C)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178DFC8-01A3-7F3F-6D2E-8A49864D4F98}"/>
              </a:ext>
            </a:extLst>
          </p:cNvPr>
          <p:cNvSpPr txBox="1"/>
          <p:nvPr/>
        </p:nvSpPr>
        <p:spPr>
          <a:xfrm>
            <a:off x="85726" y="5948218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D)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542816A-F70D-1CCA-FF62-28871F0426DC}"/>
              </a:ext>
            </a:extLst>
          </p:cNvPr>
          <p:cNvSpPr txBox="1"/>
          <p:nvPr/>
        </p:nvSpPr>
        <p:spPr>
          <a:xfrm>
            <a:off x="2124297" y="1145957"/>
            <a:ext cx="33368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0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13A737B-44F4-EF82-7B36-DFD77D5B512B}"/>
              </a:ext>
            </a:extLst>
          </p:cNvPr>
          <p:cNvSpPr txBox="1"/>
          <p:nvPr/>
        </p:nvSpPr>
        <p:spPr>
          <a:xfrm>
            <a:off x="2127841" y="1014266"/>
            <a:ext cx="33368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0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F7A40EC-AA68-6EB7-C3EE-30D5E5FEBF8D}"/>
              </a:ext>
            </a:extLst>
          </p:cNvPr>
          <p:cNvSpPr txBox="1"/>
          <p:nvPr/>
        </p:nvSpPr>
        <p:spPr>
          <a:xfrm>
            <a:off x="2175962" y="1251300"/>
            <a:ext cx="29573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0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8436848-817A-D4A1-D452-7B2AA02A3AC2}"/>
              </a:ext>
            </a:extLst>
          </p:cNvPr>
          <p:cNvSpPr txBox="1"/>
          <p:nvPr/>
        </p:nvSpPr>
        <p:spPr>
          <a:xfrm>
            <a:off x="2194937" y="1361865"/>
            <a:ext cx="276764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5EB27B9-FAB9-D900-06A0-C182C72E4464}"/>
              </a:ext>
            </a:extLst>
          </p:cNvPr>
          <p:cNvSpPr txBox="1"/>
          <p:nvPr/>
        </p:nvSpPr>
        <p:spPr>
          <a:xfrm>
            <a:off x="2174051" y="1476235"/>
            <a:ext cx="29573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8E6DE3E-BBC0-348C-002F-D5CDE7A5D3CA}"/>
              </a:ext>
            </a:extLst>
          </p:cNvPr>
          <p:cNvSpPr txBox="1"/>
          <p:nvPr/>
        </p:nvSpPr>
        <p:spPr>
          <a:xfrm>
            <a:off x="2198217" y="1654372"/>
            <a:ext cx="276764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E57BEEB-985F-7B19-5071-615C59F2590E}"/>
              </a:ext>
            </a:extLst>
          </p:cNvPr>
          <p:cNvSpPr txBox="1"/>
          <p:nvPr/>
        </p:nvSpPr>
        <p:spPr>
          <a:xfrm>
            <a:off x="3560123" y="1209275"/>
            <a:ext cx="33368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0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93E156E-DD16-CEF4-89F9-3080B50625D2}"/>
              </a:ext>
            </a:extLst>
          </p:cNvPr>
          <p:cNvSpPr txBox="1"/>
          <p:nvPr/>
        </p:nvSpPr>
        <p:spPr>
          <a:xfrm>
            <a:off x="3546771" y="1090993"/>
            <a:ext cx="33368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0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BB35630-103D-D38A-7175-3907858A63CA}"/>
              </a:ext>
            </a:extLst>
          </p:cNvPr>
          <p:cNvSpPr txBox="1"/>
          <p:nvPr/>
        </p:nvSpPr>
        <p:spPr>
          <a:xfrm>
            <a:off x="3596831" y="1316444"/>
            <a:ext cx="29573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0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AA55BA7-9AD6-6018-E87A-C0341F28112E}"/>
              </a:ext>
            </a:extLst>
          </p:cNvPr>
          <p:cNvSpPr txBox="1"/>
          <p:nvPr/>
        </p:nvSpPr>
        <p:spPr>
          <a:xfrm>
            <a:off x="3619424" y="1424024"/>
            <a:ext cx="276764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006A7F5-2EBC-A5F4-829B-059D855FB127}"/>
              </a:ext>
            </a:extLst>
          </p:cNvPr>
          <p:cNvSpPr txBox="1"/>
          <p:nvPr/>
        </p:nvSpPr>
        <p:spPr>
          <a:xfrm>
            <a:off x="3594208" y="1507843"/>
            <a:ext cx="295739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FE4C52B-8963-687C-08D6-33AB0D7BD74B}"/>
              </a:ext>
            </a:extLst>
          </p:cNvPr>
          <p:cNvSpPr txBox="1"/>
          <p:nvPr/>
        </p:nvSpPr>
        <p:spPr>
          <a:xfrm>
            <a:off x="3611276" y="1812988"/>
            <a:ext cx="276764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DEB892B-01EF-29BD-225A-AAC4196B25B6}"/>
              </a:ext>
            </a:extLst>
          </p:cNvPr>
          <p:cNvSpPr txBox="1"/>
          <p:nvPr/>
        </p:nvSpPr>
        <p:spPr>
          <a:xfrm>
            <a:off x="3603696" y="2017821"/>
            <a:ext cx="276764" cy="1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-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C82DB6B-09B2-60E9-545A-C4AF3067D34B}"/>
              </a:ext>
            </a:extLst>
          </p:cNvPr>
          <p:cNvSpPr txBox="1"/>
          <p:nvPr/>
        </p:nvSpPr>
        <p:spPr>
          <a:xfrm rot="17941126">
            <a:off x="2248090" y="613701"/>
            <a:ext cx="678421" cy="182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A0C4C41-F4CF-75FB-E3A0-6E601399A04B}"/>
              </a:ext>
            </a:extLst>
          </p:cNvPr>
          <p:cNvSpPr txBox="1"/>
          <p:nvPr/>
        </p:nvSpPr>
        <p:spPr>
          <a:xfrm rot="18060224">
            <a:off x="2745570" y="628362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BP-Fc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66238D8-11F1-D9BB-45FD-4C846A8898AB}"/>
              </a:ext>
            </a:extLst>
          </p:cNvPr>
          <p:cNvSpPr txBox="1"/>
          <p:nvPr/>
        </p:nvSpPr>
        <p:spPr>
          <a:xfrm rot="17941126">
            <a:off x="3722986" y="622499"/>
            <a:ext cx="678421" cy="182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(kDa)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9841B51-83DC-82B6-4844-7DFC5EE152CC}"/>
              </a:ext>
            </a:extLst>
          </p:cNvPr>
          <p:cNvSpPr txBox="1"/>
          <p:nvPr/>
        </p:nvSpPr>
        <p:spPr>
          <a:xfrm rot="18060224">
            <a:off x="4230269" y="629900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BP-Fc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A998BDD-9CB3-308D-5628-65BA24E467B2}"/>
              </a:ext>
            </a:extLst>
          </p:cNvPr>
          <p:cNvSpPr txBox="1"/>
          <p:nvPr/>
        </p:nvSpPr>
        <p:spPr>
          <a:xfrm>
            <a:off x="4626614" y="1237724"/>
            <a:ext cx="5020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~95 kDa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43FCEB22-B7CC-272E-31C4-E00C3D3A8851}"/>
              </a:ext>
            </a:extLst>
          </p:cNvPr>
          <p:cNvCxnSpPr>
            <a:cxnSpLocks/>
          </p:cNvCxnSpPr>
          <p:nvPr/>
        </p:nvCxnSpPr>
        <p:spPr>
          <a:xfrm flipH="1">
            <a:off x="4540614" y="1337752"/>
            <a:ext cx="137179" cy="0"/>
          </a:xfrm>
          <a:prstGeom prst="straightConnector1">
            <a:avLst/>
          </a:prstGeom>
          <a:ln w="63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0EBDF26E-5322-D231-3219-1C414E54B725}"/>
              </a:ext>
            </a:extLst>
          </p:cNvPr>
          <p:cNvSpPr txBox="1"/>
          <p:nvPr/>
        </p:nvSpPr>
        <p:spPr>
          <a:xfrm>
            <a:off x="3113845" y="1158474"/>
            <a:ext cx="5020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~95 kDa</a:t>
            </a:r>
            <a:endParaRPr lang="en-IN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FE051148-ED45-2FA0-23D4-8C1881AF018C}"/>
              </a:ext>
            </a:extLst>
          </p:cNvPr>
          <p:cNvCxnSpPr>
            <a:cxnSpLocks/>
          </p:cNvCxnSpPr>
          <p:nvPr/>
        </p:nvCxnSpPr>
        <p:spPr>
          <a:xfrm flipH="1">
            <a:off x="3027845" y="1258502"/>
            <a:ext cx="137179" cy="0"/>
          </a:xfrm>
          <a:prstGeom prst="straightConnector1">
            <a:avLst/>
          </a:prstGeom>
          <a:ln w="63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" name="Picture 4">
            <a:extLst>
              <a:ext uri="{FF2B5EF4-FFF2-40B4-BE49-F238E27FC236}">
                <a16:creationId xmlns:a16="http://schemas.microsoft.com/office/drawing/2014/main" id="{B52CB50C-4BE9-D049-FD0B-F508F615067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/>
          <a:stretch>
            <a:fillRect/>
          </a:stretch>
        </p:blipFill>
        <p:spPr>
          <a:xfrm>
            <a:off x="2304344" y="2917021"/>
            <a:ext cx="2553056" cy="2872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81995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9B3619D-05D9-54CC-2152-72655E1F51C7}"/>
              </a:ext>
            </a:extLst>
          </p:cNvPr>
          <p:cNvGrpSpPr/>
          <p:nvPr/>
        </p:nvGrpSpPr>
        <p:grpSpPr>
          <a:xfrm>
            <a:off x="0" y="822187"/>
            <a:ext cx="6821484" cy="5821948"/>
            <a:chOff x="3179297" y="368450"/>
            <a:chExt cx="7129134" cy="595148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F8FE2A7-3925-3461-570D-FA833E3415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9298" y="990260"/>
              <a:ext cx="2437763" cy="229872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39CA538-0F57-CFED-0525-1BAE31678E6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00162" y="990260"/>
              <a:ext cx="2562583" cy="243874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9F4C8AB-5951-530D-3868-A6FA2CEDFD2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11553" y="1071233"/>
              <a:ext cx="2372056" cy="227679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211802F-1961-A5BE-AA5C-3F83A69FA122}"/>
                </a:ext>
              </a:extLst>
            </p:cNvPr>
            <p:cNvSpPr txBox="1"/>
            <p:nvPr/>
          </p:nvSpPr>
          <p:spPr>
            <a:xfrm>
              <a:off x="6565534" y="827227"/>
              <a:ext cx="5302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LFA-1</a:t>
              </a:r>
              <a:endParaRPr lang="en-IN" sz="120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1CFF5EC-87AB-15EF-AF34-740D97955552}"/>
                </a:ext>
              </a:extLst>
            </p:cNvPr>
            <p:cNvSpPr txBox="1"/>
            <p:nvPr/>
          </p:nvSpPr>
          <p:spPr>
            <a:xfrm>
              <a:off x="5024214" y="368450"/>
              <a:ext cx="3221667" cy="377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/>
                <a:t>NK cells LFA-1 (CD11a) binding</a:t>
              </a:r>
              <a:endParaRPr lang="en-IN" b="1" u="sng" dirty="0"/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7E3A36C-24D0-04AB-8659-368EC57CF84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9297" y="4021206"/>
              <a:ext cx="2437763" cy="229872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51B98E9-7265-2583-6B18-3324CC0692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24983" y="4043139"/>
              <a:ext cx="2437762" cy="218734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F593B53-6335-071F-D6CE-F7CE41E8EBE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4"/>
            <a:stretch/>
          </p:blipFill>
          <p:spPr>
            <a:xfrm>
              <a:off x="7811553" y="3931760"/>
              <a:ext cx="2496878" cy="2298727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6728BA9-DDE6-E79C-B41F-9558C928098B}"/>
                </a:ext>
              </a:extLst>
            </p:cNvPr>
            <p:cNvSpPr txBox="1"/>
            <p:nvPr/>
          </p:nvSpPr>
          <p:spPr>
            <a:xfrm>
              <a:off x="5210665" y="3495254"/>
              <a:ext cx="3074239" cy="377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/>
                <a:t>THP1 LFA -1 (CD11a)  binding</a:t>
              </a:r>
              <a:endParaRPr lang="en-IN" b="1" u="sng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BDFAB08-E761-DCDB-A0B5-00CA5E176255}"/>
                </a:ext>
              </a:extLst>
            </p:cNvPr>
            <p:cNvSpPr txBox="1"/>
            <p:nvPr/>
          </p:nvSpPr>
          <p:spPr>
            <a:xfrm>
              <a:off x="3921479" y="827228"/>
              <a:ext cx="1478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G (Control)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C1C2414-176E-5D9A-BF29-EAF458C381FA}"/>
                </a:ext>
              </a:extLst>
            </p:cNvPr>
            <p:cNvSpPr txBox="1"/>
            <p:nvPr/>
          </p:nvSpPr>
          <p:spPr>
            <a:xfrm>
              <a:off x="8391778" y="851759"/>
              <a:ext cx="15304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/>
                <a:t>LFA-1 siRNA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12CD09C-7292-080F-E14C-E44893825F97}"/>
                </a:ext>
              </a:extLst>
            </p:cNvPr>
            <p:cNvSpPr txBox="1"/>
            <p:nvPr/>
          </p:nvSpPr>
          <p:spPr>
            <a:xfrm>
              <a:off x="6630865" y="3819933"/>
              <a:ext cx="5302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LFA-1</a:t>
              </a:r>
              <a:endParaRPr lang="en-IN" sz="12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4BED5D8-DA5B-317C-F607-A0BEEAB5A147}"/>
                </a:ext>
              </a:extLst>
            </p:cNvPr>
            <p:cNvSpPr txBox="1"/>
            <p:nvPr/>
          </p:nvSpPr>
          <p:spPr>
            <a:xfrm>
              <a:off x="3921479" y="3819934"/>
              <a:ext cx="1478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G (Control)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E8C7AB0-58DE-1576-D086-38AE4084FE8A}"/>
                </a:ext>
              </a:extLst>
            </p:cNvPr>
            <p:cNvSpPr txBox="1"/>
            <p:nvPr/>
          </p:nvSpPr>
          <p:spPr>
            <a:xfrm>
              <a:off x="8391778" y="3851637"/>
              <a:ext cx="15304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/>
                <a:t>LFA-1 siRNA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B67383D-0C12-86CE-A9A5-7BE2E8C7E2CE}"/>
              </a:ext>
            </a:extLst>
          </p:cNvPr>
          <p:cNvSpPr txBox="1"/>
          <p:nvPr/>
        </p:nvSpPr>
        <p:spPr>
          <a:xfrm>
            <a:off x="85726" y="8572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Suppl. Figure 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0B40D7-C55A-F048-B512-E1B9112295B1}"/>
              </a:ext>
            </a:extLst>
          </p:cNvPr>
          <p:cNvSpPr txBox="1"/>
          <p:nvPr/>
        </p:nvSpPr>
        <p:spPr>
          <a:xfrm>
            <a:off x="36516" y="453956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A)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BBEB92-4C78-98AA-AE64-BADFE9ED13D1}"/>
              </a:ext>
            </a:extLst>
          </p:cNvPr>
          <p:cNvSpPr txBox="1"/>
          <p:nvPr/>
        </p:nvSpPr>
        <p:spPr>
          <a:xfrm>
            <a:off x="85726" y="3736912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B).</a:t>
            </a:r>
          </a:p>
        </p:txBody>
      </p:sp>
    </p:spTree>
    <p:extLst>
      <p:ext uri="{BB962C8B-B14F-4D97-AF65-F5344CB8AC3E}">
        <p14:creationId xmlns:p14="http://schemas.microsoft.com/office/powerpoint/2010/main" val="11745798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E39D6FF-1EB6-92E3-ECE5-DD6179EB0E7F}"/>
              </a:ext>
            </a:extLst>
          </p:cNvPr>
          <p:cNvSpPr txBox="1"/>
          <p:nvPr/>
        </p:nvSpPr>
        <p:spPr>
          <a:xfrm>
            <a:off x="55294" y="-7576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Suppl. Figure 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E345A7D-393B-67F4-25A0-D96043FBAB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7498" y="5166508"/>
            <a:ext cx="2040553" cy="178815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3BC8DED-9846-439D-008E-6FAB9DB6448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050" y="5106864"/>
            <a:ext cx="2044811" cy="183774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DE22B19-1A8E-4FC3-5253-A1A048FCF0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3788" y="1244074"/>
            <a:ext cx="1833247" cy="173912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01F8C2B-875A-7D74-FB3A-DA3A03B53189}"/>
              </a:ext>
            </a:extLst>
          </p:cNvPr>
          <p:cNvSpPr txBox="1"/>
          <p:nvPr/>
        </p:nvSpPr>
        <p:spPr>
          <a:xfrm>
            <a:off x="2055384" y="1106491"/>
            <a:ext cx="1288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P-1 + hIgG 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2E14F02-5143-426F-8682-C0797090E3A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620" y="1244074"/>
            <a:ext cx="2044811" cy="178815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AEE2E7E-1D04-57AA-2F61-3A6E7CB9E676}"/>
              </a:ext>
            </a:extLst>
          </p:cNvPr>
          <p:cNvSpPr txBox="1"/>
          <p:nvPr/>
        </p:nvSpPr>
        <p:spPr>
          <a:xfrm>
            <a:off x="3765840" y="1106882"/>
            <a:ext cx="1663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P-1 +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c 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CFBC52E-A66C-CCE7-E387-ECA3367B8AF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1612" y="3224845"/>
            <a:ext cx="1772107" cy="168515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FC8D3B2-0275-C2CA-29EA-9CD126AEC3A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1722" y="3166218"/>
            <a:ext cx="1772107" cy="174378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997A999-FE5C-B769-7875-D18F45D8CA60}"/>
              </a:ext>
            </a:extLst>
          </p:cNvPr>
          <p:cNvSpPr txBox="1"/>
          <p:nvPr/>
        </p:nvSpPr>
        <p:spPr>
          <a:xfrm>
            <a:off x="1992792" y="3013230"/>
            <a:ext cx="1078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 +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G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E50C508-14B6-1385-8328-5A2B785FE830}"/>
              </a:ext>
            </a:extLst>
          </p:cNvPr>
          <p:cNvSpPr txBox="1"/>
          <p:nvPr/>
        </p:nvSpPr>
        <p:spPr>
          <a:xfrm>
            <a:off x="3826039" y="3013230"/>
            <a:ext cx="1454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 +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2248182-AE5E-2C14-426C-0C96E9B9AF19}"/>
              </a:ext>
            </a:extLst>
          </p:cNvPr>
          <p:cNvSpPr txBox="1"/>
          <p:nvPr/>
        </p:nvSpPr>
        <p:spPr>
          <a:xfrm>
            <a:off x="1986462" y="4919030"/>
            <a:ext cx="116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G2 +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G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F18AFCA-2033-7165-EC17-9D1C8CD6E50D}"/>
              </a:ext>
            </a:extLst>
          </p:cNvPr>
          <p:cNvSpPr txBox="1"/>
          <p:nvPr/>
        </p:nvSpPr>
        <p:spPr>
          <a:xfrm>
            <a:off x="3628132" y="4919030"/>
            <a:ext cx="1729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G2 +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BP130-F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A5FF0A2-1FE3-0078-EA97-024DB7BCEC6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268" y="7103802"/>
            <a:ext cx="2048794" cy="183882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FC5C205-E5C7-797F-C5FF-A75E31855DB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25"/>
          <a:stretch>
            <a:fillRect/>
          </a:stretch>
        </p:blipFill>
        <p:spPr>
          <a:xfrm>
            <a:off x="3393719" y="7066068"/>
            <a:ext cx="1954300" cy="1822649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4C3862D-B1DB-35B3-980F-47274814A62F}"/>
              </a:ext>
            </a:extLst>
          </p:cNvPr>
          <p:cNvSpPr txBox="1"/>
          <p:nvPr/>
        </p:nvSpPr>
        <p:spPr>
          <a:xfrm>
            <a:off x="1986462" y="6965302"/>
            <a:ext cx="13260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m cell  +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G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564A76-ECDE-6300-766B-8480BBB979ED}"/>
              </a:ext>
            </a:extLst>
          </p:cNvPr>
          <p:cNvSpPr txBox="1"/>
          <p:nvPr/>
        </p:nvSpPr>
        <p:spPr>
          <a:xfrm>
            <a:off x="3565005" y="6944605"/>
            <a:ext cx="18934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m cell  +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BP130-Fc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CBAD6EC-5980-92C9-85C5-0162118B4AE3}"/>
              </a:ext>
            </a:extLst>
          </p:cNvPr>
          <p:cNvSpPr txBox="1"/>
          <p:nvPr/>
        </p:nvSpPr>
        <p:spPr>
          <a:xfrm>
            <a:off x="956886" y="99658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A)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9987A8C-1EAA-00BC-3AD1-723A1E9FAF55}"/>
              </a:ext>
            </a:extLst>
          </p:cNvPr>
          <p:cNvSpPr txBox="1"/>
          <p:nvPr/>
        </p:nvSpPr>
        <p:spPr>
          <a:xfrm>
            <a:off x="952598" y="2833027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B)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7C0F79B-5E92-566C-BE68-6CB184F55D6B}"/>
              </a:ext>
            </a:extLst>
          </p:cNvPr>
          <p:cNvSpPr txBox="1"/>
          <p:nvPr/>
        </p:nvSpPr>
        <p:spPr>
          <a:xfrm>
            <a:off x="952598" y="4818541"/>
            <a:ext cx="439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C)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C69CC69-474B-6C98-D111-5E137C270393}"/>
              </a:ext>
            </a:extLst>
          </p:cNvPr>
          <p:cNvSpPr txBox="1"/>
          <p:nvPr/>
        </p:nvSpPr>
        <p:spPr>
          <a:xfrm>
            <a:off x="952598" y="6726507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/>
              <a:t>(D).</a:t>
            </a:r>
          </a:p>
        </p:txBody>
      </p:sp>
    </p:spTree>
    <p:extLst>
      <p:ext uri="{BB962C8B-B14F-4D97-AF65-F5344CB8AC3E}">
        <p14:creationId xmlns:p14="http://schemas.microsoft.com/office/powerpoint/2010/main" val="9062487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F56FA58-9A8F-8EC2-62D7-3D5FF64571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271" y="864704"/>
            <a:ext cx="6459458" cy="76549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00D3894-A9A3-0D2C-D015-7BE4A37687DE}"/>
              </a:ext>
            </a:extLst>
          </p:cNvPr>
          <p:cNvSpPr txBox="1"/>
          <p:nvPr/>
        </p:nvSpPr>
        <p:spPr>
          <a:xfrm>
            <a:off x="897123" y="333510"/>
            <a:ext cx="48699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Table 1: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of MS/MS hits of the </a:t>
            </a:r>
            <a:r>
              <a:rPr lang="en-I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ads+hIgG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</a:t>
            </a:r>
          </a:p>
        </p:txBody>
      </p:sp>
    </p:spTree>
    <p:extLst>
      <p:ext uri="{BB962C8B-B14F-4D97-AF65-F5344CB8AC3E}">
        <p14:creationId xmlns:p14="http://schemas.microsoft.com/office/powerpoint/2010/main" val="22296510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8D66FB7-7096-4E62-D11B-5A22B43F85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0630734"/>
              </p:ext>
            </p:extLst>
          </p:nvPr>
        </p:nvGraphicFramePr>
        <p:xfrm>
          <a:off x="825003" y="1507035"/>
          <a:ext cx="5522504" cy="2799907"/>
        </p:xfrm>
        <a:graphic>
          <a:graphicData uri="http://schemas.openxmlformats.org/drawingml/2006/table">
            <a:tbl>
              <a:tblPr firstRow="1" firstCol="1" bandRow="1">
                <a:tableStyleId>{8799B23B-EC83-4686-B30A-512413B5E67A}</a:tableStyleId>
              </a:tblPr>
              <a:tblGrid>
                <a:gridCol w="1768996">
                  <a:extLst>
                    <a:ext uri="{9D8B030D-6E8A-4147-A177-3AD203B41FA5}">
                      <a16:colId xmlns:a16="http://schemas.microsoft.com/office/drawing/2014/main" val="1501980325"/>
                    </a:ext>
                  </a:extLst>
                </a:gridCol>
                <a:gridCol w="883395">
                  <a:extLst>
                    <a:ext uri="{9D8B030D-6E8A-4147-A177-3AD203B41FA5}">
                      <a16:colId xmlns:a16="http://schemas.microsoft.com/office/drawing/2014/main" val="3306662433"/>
                    </a:ext>
                  </a:extLst>
                </a:gridCol>
                <a:gridCol w="1326195">
                  <a:extLst>
                    <a:ext uri="{9D8B030D-6E8A-4147-A177-3AD203B41FA5}">
                      <a16:colId xmlns:a16="http://schemas.microsoft.com/office/drawing/2014/main" val="3988484498"/>
                    </a:ext>
                  </a:extLst>
                </a:gridCol>
                <a:gridCol w="1543918">
                  <a:extLst>
                    <a:ext uri="{9D8B030D-6E8A-4147-A177-3AD203B41FA5}">
                      <a16:colId xmlns:a16="http://schemas.microsoft.com/office/drawing/2014/main" val="2618055543"/>
                    </a:ext>
                  </a:extLst>
                </a:gridCol>
              </a:tblGrid>
              <a:tr h="347345"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Scores from </a:t>
                      </a:r>
                      <a:r>
                        <a:rPr lang="en-US" sz="1200" kern="100" dirty="0" err="1">
                          <a:effectLst/>
                        </a:rPr>
                        <a:t>ClusPro</a:t>
                      </a:r>
                      <a:r>
                        <a:rPr lang="en-US" sz="1200" kern="100" dirty="0">
                          <a:effectLst/>
                        </a:rPr>
                        <a:t> 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367441"/>
                  </a:ext>
                </a:extLst>
              </a:tr>
              <a:tr h="45085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Complex Name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Cluster Member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Weighted Score-Center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Weighted Score-Lowest Energy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74901085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1200" kern="100" dirty="0">
                          <a:effectLst/>
                        </a:rPr>
                        <a:t>LFA1/</a:t>
                      </a:r>
                      <a:r>
                        <a:rPr lang="en-IN" sz="1200" i="1" kern="100" dirty="0">
                          <a:effectLst/>
                        </a:rPr>
                        <a:t>Pf</a:t>
                      </a:r>
                      <a:r>
                        <a:rPr lang="en-IN" sz="1200" kern="100" dirty="0">
                          <a:effectLst/>
                        </a:rPr>
                        <a:t>GBP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226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1200" kern="100">
                          <a:effectLst/>
                        </a:rPr>
                        <a:t>-805.6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1200" kern="100">
                          <a:effectLst/>
                        </a:rPr>
                        <a:t>-834.0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4005379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1353594"/>
                  </a:ext>
                </a:extLst>
              </a:tr>
              <a:tr h="347345"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Binding free Energy (kcal/mol) for </a:t>
                      </a:r>
                      <a:r>
                        <a:rPr lang="en-IN" sz="1200" kern="100" dirty="0">
                          <a:effectLst/>
                        </a:rPr>
                        <a:t>LFA1/</a:t>
                      </a:r>
                      <a:r>
                        <a:rPr lang="en-IN" sz="1200" i="1" kern="100" dirty="0">
                          <a:effectLst/>
                        </a:rPr>
                        <a:t>Pf</a:t>
                      </a:r>
                      <a:r>
                        <a:rPr lang="en-IN" sz="1200" kern="100" dirty="0">
                          <a:effectLst/>
                        </a:rPr>
                        <a:t>GBP complex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278536"/>
                  </a:ext>
                </a:extLst>
              </a:tr>
              <a:tr h="27114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PRODIGY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-9.8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4"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 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4"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9908886"/>
                  </a:ext>
                </a:extLst>
              </a:tr>
              <a:tr h="2565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HawkDock server V2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-22.2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3531793"/>
                  </a:ext>
                </a:extLst>
              </a:tr>
              <a:tr h="2692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PPCheck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-7.6 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073738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AREA-AFFINITY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1200" kern="100">
                          <a:effectLst/>
                        </a:rPr>
                        <a:t>-10.14</a:t>
                      </a:r>
                      <a:endParaRPr lang="en-IN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4390230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en-IN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23597829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BCC88A2F-AAF7-7BF1-03C0-E1095A8344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690" y="830525"/>
            <a:ext cx="585696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. Table 2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: Docking scores and binding energy calculated using various computational tools to assess the quality of the GBP-LFA1 docked complex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918719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844</TotalTime>
  <Words>283</Words>
  <Application>Microsoft Office PowerPoint</Application>
  <PresentationFormat>A4 Paper (210x297 mm)</PresentationFormat>
  <Paragraphs>89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shutosh Panda</dc:creator>
  <cp:lastModifiedBy>Ashutosh Panda</cp:lastModifiedBy>
  <cp:revision>26</cp:revision>
  <cp:lastPrinted>2026-02-03T09:45:58Z</cp:lastPrinted>
  <dcterms:created xsi:type="dcterms:W3CDTF">2025-05-12T09:06:20Z</dcterms:created>
  <dcterms:modified xsi:type="dcterms:W3CDTF">2026-03-06T08:03:24Z</dcterms:modified>
</cp:coreProperties>
</file>